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797675" cy="99298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1506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osario\Desktop\charo\postdoc%20UCM\uarray%20trucha\articulo%20uarray%20trucha\analisis%20nuevo\02_uarray_graph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heat shock</a:t>
            </a:r>
            <a:r>
              <a:rPr lang="en-GB" baseline="0"/>
              <a:t> proteins</a:t>
            </a:r>
            <a:endParaRPr lang="en-GB"/>
          </a:p>
        </c:rich>
      </c:tx>
      <c:layout/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0.10629708970202253"/>
          <c:y val="0.20964107488152736"/>
          <c:w val="0.87007140651536208"/>
          <c:h val="0.60657117691252915"/>
        </c:manualLayout>
      </c:layout>
      <c:barChart>
        <c:barDir val="col"/>
        <c:grouping val="clustered"/>
        <c:varyColors val="0"/>
        <c:ser>
          <c:idx val="0"/>
          <c:order val="0"/>
          <c:tx>
            <c:v>Spleen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hsp!$Q$139:$Q$180</c:f>
              <c:strCache>
                <c:ptCount val="42"/>
                <c:pt idx="0">
                  <c:v>cu chaperon</c:v>
                </c:pt>
                <c:pt idx="1">
                  <c:v>tub chaperon</c:v>
                </c:pt>
                <c:pt idx="2">
                  <c:v>dnaj</c:v>
                </c:pt>
                <c:pt idx="3">
                  <c:v>pg e</c:v>
                </c:pt>
                <c:pt idx="4">
                  <c:v>ubiquitin</c:v>
                </c:pt>
                <c:pt idx="5">
                  <c:v>a tubulin</c:v>
                </c:pt>
                <c:pt idx="6">
                  <c:v>prefoldin s1</c:v>
                </c:pt>
                <c:pt idx="7">
                  <c:v>prefoldin s4</c:v>
                </c:pt>
                <c:pt idx="8">
                  <c:v>prefoldin s6</c:v>
                </c:pt>
                <c:pt idx="9">
                  <c:v>cyt c chaperon</c:v>
                </c:pt>
                <c:pt idx="10">
                  <c:v>atox1</c:v>
                </c:pt>
                <c:pt idx="11">
                  <c:v>p53</c:v>
                </c:pt>
                <c:pt idx="12">
                  <c:v>pstpip2</c:v>
                </c:pt>
                <c:pt idx="13">
                  <c:v>psmb9a</c:v>
                </c:pt>
                <c:pt idx="14">
                  <c:v>psm d</c:v>
                </c:pt>
                <c:pt idx="15">
                  <c:v>psmb9</c:v>
                </c:pt>
                <c:pt idx="16">
                  <c:v>lmp2</c:v>
                </c:pt>
                <c:pt idx="17">
                  <c:v>psm c10</c:v>
                </c:pt>
                <c:pt idx="18">
                  <c:v>prolactin r</c:v>
                </c:pt>
                <c:pt idx="19">
                  <c:v>ddit4l</c:v>
                </c:pt>
                <c:pt idx="20">
                  <c:v>eif2a</c:v>
                </c:pt>
                <c:pt idx="21">
                  <c:v>grp78</c:v>
                </c:pt>
                <c:pt idx="22">
                  <c:v>grp94</c:v>
                </c:pt>
                <c:pt idx="23">
                  <c:v>chitinase</c:v>
                </c:pt>
                <c:pt idx="24">
                  <c:v>collagenase</c:v>
                </c:pt>
                <c:pt idx="25">
                  <c:v>pre cath c</c:v>
                </c:pt>
                <c:pt idx="26">
                  <c:v>pro cath l</c:v>
                </c:pt>
                <c:pt idx="27">
                  <c:v>pro cath b</c:v>
                </c:pt>
                <c:pt idx="28">
                  <c:v>cath a</c:v>
                </c:pt>
                <c:pt idx="29">
                  <c:v>cath b</c:v>
                </c:pt>
                <c:pt idx="30">
                  <c:v>cath d</c:v>
                </c:pt>
                <c:pt idx="31">
                  <c:v>cath f</c:v>
                </c:pt>
                <c:pt idx="32">
                  <c:v>cath k</c:v>
                </c:pt>
                <c:pt idx="33">
                  <c:v>cath l</c:v>
                </c:pt>
                <c:pt idx="34">
                  <c:v>cath s</c:v>
                </c:pt>
                <c:pt idx="35">
                  <c:v>cath y</c:v>
                </c:pt>
                <c:pt idx="36">
                  <c:v>cath z</c:v>
                </c:pt>
                <c:pt idx="37">
                  <c:v>hsp10</c:v>
                </c:pt>
                <c:pt idx="38">
                  <c:v>hsp27</c:v>
                </c:pt>
                <c:pt idx="39">
                  <c:v>hsp40</c:v>
                </c:pt>
                <c:pt idx="40">
                  <c:v>hsp70</c:v>
                </c:pt>
                <c:pt idx="41">
                  <c:v>hsp90ß</c:v>
                </c:pt>
              </c:strCache>
            </c:strRef>
          </c:cat>
          <c:val>
            <c:numRef>
              <c:f>hsp!$R$139:$R$180</c:f>
              <c:numCache>
                <c:formatCode>General</c:formatCode>
                <c:ptCount val="42"/>
                <c:pt idx="0">
                  <c:v>2.7032226310430798</c:v>
                </c:pt>
                <c:pt idx="1">
                  <c:v>1.73032753232731</c:v>
                </c:pt>
                <c:pt idx="2">
                  <c:v>2.3670283727165402</c:v>
                </c:pt>
                <c:pt idx="3">
                  <c:v>3.0687956323285901</c:v>
                </c:pt>
                <c:pt idx="4">
                  <c:v>3.6754304993100702</c:v>
                </c:pt>
                <c:pt idx="5">
                  <c:v>3.7180815555040301</c:v>
                </c:pt>
                <c:pt idx="6">
                  <c:v>2.7178111719943798</c:v>
                </c:pt>
                <c:pt idx="7">
                  <c:v>2.4645240245246698</c:v>
                </c:pt>
                <c:pt idx="8">
                  <c:v>2.7178111719943798</c:v>
                </c:pt>
                <c:pt idx="9">
                  <c:v>2.59054140001775</c:v>
                </c:pt>
                <c:pt idx="10">
                  <c:v>2.1654797044377001</c:v>
                </c:pt>
                <c:pt idx="11">
                  <c:v>1.81036667076761</c:v>
                </c:pt>
                <c:pt idx="12">
                  <c:v>1.9661699101490999</c:v>
                </c:pt>
                <c:pt idx="13">
                  <c:v>3.6016482862657502</c:v>
                </c:pt>
                <c:pt idx="14">
                  <c:v>3.2632446123703498</c:v>
                </c:pt>
                <c:pt idx="15">
                  <c:v>2.8366737614729098</c:v>
                </c:pt>
                <c:pt idx="16">
                  <c:v>4.1606442193939897</c:v>
                </c:pt>
                <c:pt idx="17">
                  <c:v>-2.2090533318810799</c:v>
                </c:pt>
                <c:pt idx="18">
                  <c:v>-2.5898149319563699</c:v>
                </c:pt>
                <c:pt idx="19">
                  <c:v>-1.82759636050621</c:v>
                </c:pt>
                <c:pt idx="20">
                  <c:v>3.3842074184926898</c:v>
                </c:pt>
                <c:pt idx="21">
                  <c:v>4.1080639371055101</c:v>
                </c:pt>
                <c:pt idx="22">
                  <c:v>3.7669878416431102</c:v>
                </c:pt>
                <c:pt idx="23">
                  <c:v>4.0106909313676304</c:v>
                </c:pt>
                <c:pt idx="24">
                  <c:v>2.5402707634195401</c:v>
                </c:pt>
                <c:pt idx="25">
                  <c:v>4.1369091880984898</c:v>
                </c:pt>
                <c:pt idx="26">
                  <c:v>4.1816911281944904</c:v>
                </c:pt>
                <c:pt idx="27">
                  <c:v>-1.85623442995938</c:v>
                </c:pt>
                <c:pt idx="28">
                  <c:v>3.37448042027646</c:v>
                </c:pt>
                <c:pt idx="29">
                  <c:v>4.3447323504368001</c:v>
                </c:pt>
                <c:pt idx="30">
                  <c:v>4.2374697403944603</c:v>
                </c:pt>
                <c:pt idx="31">
                  <c:v>1.25944849663404</c:v>
                </c:pt>
                <c:pt idx="32">
                  <c:v>3.22413973854407</c:v>
                </c:pt>
                <c:pt idx="33">
                  <c:v>1.9662243293352799</c:v>
                </c:pt>
                <c:pt idx="34">
                  <c:v>4.0997620444737697</c:v>
                </c:pt>
                <c:pt idx="35">
                  <c:v>3.7307754120744301</c:v>
                </c:pt>
                <c:pt idx="36">
                  <c:v>4.3374739469569397</c:v>
                </c:pt>
                <c:pt idx="37">
                  <c:v>2.8445355346939398</c:v>
                </c:pt>
                <c:pt idx="38">
                  <c:v>-2.1342152478307801</c:v>
                </c:pt>
                <c:pt idx="39">
                  <c:v>-1.3065486038905401</c:v>
                </c:pt>
                <c:pt idx="40">
                  <c:v>3.5398617909782102</c:v>
                </c:pt>
                <c:pt idx="41">
                  <c:v>4.1959211060807204</c:v>
                </c:pt>
              </c:numCache>
            </c:numRef>
          </c:val>
        </c:ser>
        <c:ser>
          <c:idx val="1"/>
          <c:order val="1"/>
          <c:tx>
            <c:v>Kidney</c:v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hsp!$Q$139:$Q$180</c:f>
              <c:strCache>
                <c:ptCount val="42"/>
                <c:pt idx="0">
                  <c:v>cu chaperon</c:v>
                </c:pt>
                <c:pt idx="1">
                  <c:v>tub chaperon</c:v>
                </c:pt>
                <c:pt idx="2">
                  <c:v>dnaj</c:v>
                </c:pt>
                <c:pt idx="3">
                  <c:v>pg e</c:v>
                </c:pt>
                <c:pt idx="4">
                  <c:v>ubiquitin</c:v>
                </c:pt>
                <c:pt idx="5">
                  <c:v>a tubulin</c:v>
                </c:pt>
                <c:pt idx="6">
                  <c:v>prefoldin s1</c:v>
                </c:pt>
                <c:pt idx="7">
                  <c:v>prefoldin s4</c:v>
                </c:pt>
                <c:pt idx="8">
                  <c:v>prefoldin s6</c:v>
                </c:pt>
                <c:pt idx="9">
                  <c:v>cyt c chaperon</c:v>
                </c:pt>
                <c:pt idx="10">
                  <c:v>atox1</c:v>
                </c:pt>
                <c:pt idx="11">
                  <c:v>p53</c:v>
                </c:pt>
                <c:pt idx="12">
                  <c:v>pstpip2</c:v>
                </c:pt>
                <c:pt idx="13">
                  <c:v>psmb9a</c:v>
                </c:pt>
                <c:pt idx="14">
                  <c:v>psm d</c:v>
                </c:pt>
                <c:pt idx="15">
                  <c:v>psmb9</c:v>
                </c:pt>
                <c:pt idx="16">
                  <c:v>lmp2</c:v>
                </c:pt>
                <c:pt idx="17">
                  <c:v>psm c10</c:v>
                </c:pt>
                <c:pt idx="18">
                  <c:v>prolactin r</c:v>
                </c:pt>
                <c:pt idx="19">
                  <c:v>ddit4l</c:v>
                </c:pt>
                <c:pt idx="20">
                  <c:v>eif2a</c:v>
                </c:pt>
                <c:pt idx="21">
                  <c:v>grp78</c:v>
                </c:pt>
                <c:pt idx="22">
                  <c:v>grp94</c:v>
                </c:pt>
                <c:pt idx="23">
                  <c:v>chitinase</c:v>
                </c:pt>
                <c:pt idx="24">
                  <c:v>collagenase</c:v>
                </c:pt>
                <c:pt idx="25">
                  <c:v>pre cath c</c:v>
                </c:pt>
                <c:pt idx="26">
                  <c:v>pro cath l</c:v>
                </c:pt>
                <c:pt idx="27">
                  <c:v>pro cath b</c:v>
                </c:pt>
                <c:pt idx="28">
                  <c:v>cath a</c:v>
                </c:pt>
                <c:pt idx="29">
                  <c:v>cath b</c:v>
                </c:pt>
                <c:pt idx="30">
                  <c:v>cath d</c:v>
                </c:pt>
                <c:pt idx="31">
                  <c:v>cath f</c:v>
                </c:pt>
                <c:pt idx="32">
                  <c:v>cath k</c:v>
                </c:pt>
                <c:pt idx="33">
                  <c:v>cath l</c:v>
                </c:pt>
                <c:pt idx="34">
                  <c:v>cath s</c:v>
                </c:pt>
                <c:pt idx="35">
                  <c:v>cath y</c:v>
                </c:pt>
                <c:pt idx="36">
                  <c:v>cath z</c:v>
                </c:pt>
                <c:pt idx="37">
                  <c:v>hsp10</c:v>
                </c:pt>
                <c:pt idx="38">
                  <c:v>hsp27</c:v>
                </c:pt>
                <c:pt idx="39">
                  <c:v>hsp40</c:v>
                </c:pt>
                <c:pt idx="40">
                  <c:v>hsp70</c:v>
                </c:pt>
                <c:pt idx="41">
                  <c:v>hsp90ß</c:v>
                </c:pt>
              </c:strCache>
            </c:strRef>
          </c:cat>
          <c:val>
            <c:numRef>
              <c:f>hsp!$S$139:$S$180</c:f>
              <c:numCache>
                <c:formatCode>General</c:formatCode>
                <c:ptCount val="42"/>
                <c:pt idx="0">
                  <c:v>2.4646085221538101</c:v>
                </c:pt>
                <c:pt idx="1">
                  <c:v>1.47931235930136</c:v>
                </c:pt>
                <c:pt idx="2">
                  <c:v>2.21837126216951</c:v>
                </c:pt>
                <c:pt idx="3">
                  <c:v>3.2281001294418901</c:v>
                </c:pt>
                <c:pt idx="4">
                  <c:v>3.6471336372415002</c:v>
                </c:pt>
                <c:pt idx="5">
                  <c:v>3.6684310148396899</c:v>
                </c:pt>
                <c:pt idx="6">
                  <c:v>2.25057764778217</c:v>
                </c:pt>
                <c:pt idx="8">
                  <c:v>2.65347880292483</c:v>
                </c:pt>
                <c:pt idx="9">
                  <c:v>2.76527980175474</c:v>
                </c:pt>
                <c:pt idx="10">
                  <c:v>2.0640999876988602</c:v>
                </c:pt>
                <c:pt idx="11">
                  <c:v>1.79703292917807</c:v>
                </c:pt>
                <c:pt idx="12">
                  <c:v>1.3357044292676199</c:v>
                </c:pt>
                <c:pt idx="13">
                  <c:v>3.1017184987052699</c:v>
                </c:pt>
                <c:pt idx="14">
                  <c:v>3.2569617206327202</c:v>
                </c:pt>
                <c:pt idx="15">
                  <c:v>2.23731519654143</c:v>
                </c:pt>
                <c:pt idx="16">
                  <c:v>3.5686163441246701</c:v>
                </c:pt>
                <c:pt idx="17">
                  <c:v>-2.1152580762517399</c:v>
                </c:pt>
                <c:pt idx="18">
                  <c:v>-1.34279457426056</c:v>
                </c:pt>
                <c:pt idx="19">
                  <c:v>-2.3142199413609501</c:v>
                </c:pt>
                <c:pt idx="20">
                  <c:v>3.2884547073615602</c:v>
                </c:pt>
                <c:pt idx="21">
                  <c:v>3.9093296509308999</c:v>
                </c:pt>
                <c:pt idx="22">
                  <c:v>3.68926722133354</c:v>
                </c:pt>
                <c:pt idx="23">
                  <c:v>3.4250918000800699</c:v>
                </c:pt>
                <c:pt idx="24">
                  <c:v>3.0403107921385399</c:v>
                </c:pt>
                <c:pt idx="25">
                  <c:v>3.9456917912070102</c:v>
                </c:pt>
                <c:pt idx="26">
                  <c:v>3.66401235454172</c:v>
                </c:pt>
                <c:pt idx="28">
                  <c:v>3.1012453996435001</c:v>
                </c:pt>
                <c:pt idx="29">
                  <c:v>3.9770138920284199</c:v>
                </c:pt>
                <c:pt idx="30">
                  <c:v>3.8795277126816501</c:v>
                </c:pt>
                <c:pt idx="31">
                  <c:v>1.14602135443053</c:v>
                </c:pt>
                <c:pt idx="32">
                  <c:v>3.0208751918746399</c:v>
                </c:pt>
                <c:pt idx="33">
                  <c:v>1.4696579306631099</c:v>
                </c:pt>
                <c:pt idx="34">
                  <c:v>3.89279580902712</c:v>
                </c:pt>
                <c:pt idx="35">
                  <c:v>3.3900358938333501</c:v>
                </c:pt>
                <c:pt idx="36">
                  <c:v>3.8374207213657798</c:v>
                </c:pt>
                <c:pt idx="37">
                  <c:v>3.05388197326107</c:v>
                </c:pt>
                <c:pt idx="38">
                  <c:v>-1.8297877829115701</c:v>
                </c:pt>
                <c:pt idx="39">
                  <c:v>-1.37007585337431</c:v>
                </c:pt>
                <c:pt idx="40">
                  <c:v>2.4725346840015798</c:v>
                </c:pt>
                <c:pt idx="41">
                  <c:v>4.05318510424462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12413304"/>
        <c:axId val="312411736"/>
      </c:barChart>
      <c:catAx>
        <c:axId val="3124133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12411736"/>
        <c:crosses val="autoZero"/>
        <c:auto val="1"/>
        <c:lblAlgn val="ctr"/>
        <c:lblOffset val="100"/>
        <c:noMultiLvlLbl val="0"/>
      </c:catAx>
      <c:valAx>
        <c:axId val="3124117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b="1"/>
                  <a:t>LogFold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124133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621117624614103"/>
          <c:y val="5.8626589945487591E-2"/>
          <c:w val="9.9611895939478154E-2"/>
          <c:h val="0.1280236747682298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002703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65982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0637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0687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8544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75629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9451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13343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8566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98154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2456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52FBDB-E619-4D80-9E77-F978D9BEB2E7}" type="datetimeFigureOut">
              <a:rPr lang="es-ES" smtClean="0"/>
              <a:pPr/>
              <a:t>15/04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7FED52-297B-4DE9-AF24-DA0F151E8536}" type="slidenum">
              <a:rPr lang="es-ES" smtClean="0"/>
              <a:pPr/>
              <a:t>‹N°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10663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phique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14735252"/>
              </p:ext>
            </p:extLst>
          </p:nvPr>
        </p:nvGraphicFramePr>
        <p:xfrm>
          <a:off x="1043608" y="2132856"/>
          <a:ext cx="6832473" cy="31302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50395375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</TotalTime>
  <Words>4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liocoll</dc:creator>
  <cp:lastModifiedBy>ecoulamy</cp:lastModifiedBy>
  <cp:revision>35</cp:revision>
  <cp:lastPrinted>2013-10-01T10:15:10Z</cp:lastPrinted>
  <dcterms:created xsi:type="dcterms:W3CDTF">2011-12-25T10:58:06Z</dcterms:created>
  <dcterms:modified xsi:type="dcterms:W3CDTF">2019-04-15T13:31:33Z</dcterms:modified>
</cp:coreProperties>
</file>